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7689D4-7BF6-4964-AD92-054A624477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8D7976-F468-4CFB-AA4C-14DBA1FD6D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E347D3-F4F9-4780-BEF3-002DE5F9678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7C66E1-5669-4543-A81B-A97E32C4B9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4DC35C-AA0E-4E53-9B7C-36ADC4684E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11A2B8-784B-45CF-A902-74BD1D78E2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C1FA60-1494-4932-A819-000685F908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080AF7-551F-43C0-85EA-605EDB8D42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D28C46-4940-485B-B703-0D1A37C998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3FA6FE-920F-4B56-B392-CC1E4CB4E3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9F994D-4DE0-448B-9177-C3695036B9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B608C3-2A70-4FD3-8A28-80824E6E77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EA712A-4C7E-4AB8-AC24-E73429773D0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20760" y="6877080"/>
            <a:ext cx="6226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17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orrespondence between gene expression in mouse ES cells measured by microarrays [9] and RNA-seq methods [19]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2438280" y="2743200"/>
            <a:ext cx="2449800" cy="343836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 flipV="1">
            <a:off x="2590920" y="3586320"/>
            <a:ext cx="2262240" cy="1689120"/>
          </a:xfrm>
          <a:prstGeom prst="line">
            <a:avLst/>
          </a:prstGeom>
          <a:ln w="190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817720" y="2819520"/>
            <a:ext cx="144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y = 0.056 + 0.682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820240" y="3048120"/>
            <a:ext cx="70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 = 0.7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123360" y="6172200"/>
            <a:ext cx="124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icroarray da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6200000">
            <a:off x="1777320" y="4164120"/>
            <a:ext cx="114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NA-seq da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28T20:23:48Z</dcterms:created>
  <dc:creator>Alexei Sharov</dc:creator>
  <dc:description/>
  <dc:language>en-US</dc:language>
  <cp:lastModifiedBy>Alexei Sharov</cp:lastModifiedBy>
  <dcterms:modified xsi:type="dcterms:W3CDTF">2011-01-28T20:35:07Z</dcterms:modified>
  <cp:revision>6</cp:revision>
  <dc:subject/>
  <dc:title>Slide 1</dc:title>
</cp:coreProperties>
</file>